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61" r:id="rId3"/>
    <p:sldId id="274" r:id="rId4"/>
    <p:sldId id="270" r:id="rId5"/>
    <p:sldId id="27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2" autoAdjust="0"/>
    <p:restoredTop sz="86879" autoAdjust="0"/>
  </p:normalViewPr>
  <p:slideViewPr>
    <p:cSldViewPr snapToGrid="0">
      <p:cViewPr>
        <p:scale>
          <a:sx n="75" d="100"/>
          <a:sy n="75" d="100"/>
        </p:scale>
        <p:origin x="1950" y="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5684BE-4E17-42FF-9F1B-D6157B4F2DB9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47B433-8E11-4A82-B2A3-F1E47187A9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188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: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ytotoxic effects of HD on </a:t>
            </a:r>
            <a:r>
              <a:rPr lang="en-US" sz="1200" b="1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Airway</a:t>
            </a:r>
            <a:r>
              <a:rPr lang="en-US" sz="1200" b="1" i="1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b="1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s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open bar represents the mean ± SEM of relative cytotoxicity of untreate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Airway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s. The cross-hatched bar represents the mean ± SEM of relative cytotoxicity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Airway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s treated with equivalent amounts of vehicle (corn oil) for 24h. The closed bars represent the mean ± SEM of relative cytotoxicity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iAirway</a:t>
            </a:r>
            <a:r>
              <a:rPr lang="en-US" sz="1200" kern="1200" baseline="30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issues treated with increasing concentrations of HD (0.01 – 2.5 mg/mL; 0.0629-15.7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for 24h. *Significantly increased compared to vehicle control at p &lt; 0.01. SEM indicates the standard error of the mea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47B433-8E11-4A82-B2A3-F1E47187A98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9379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3: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valuation of the Inflammatory Cytokines IL-1α, IL-1β, IL-6, and TNFα 24h Following HD Exposure. Vertical bars represent mean ± SEM expressed in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g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mL of IL-1α (A), IL-1β (B), IL-6 (C) or TNFα (D). Media (open bar); Vehicle (corn oil; cross-hatched bar); HD (0.1 mg/mL; closed bar). n = 3 for each experimental condition. *Significantly increased compared to vehicle control at p &lt; 0.01. SEM indicates the standard error of the mean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47B433-8E11-4A82-B2A3-F1E47187A98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915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4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ox and whiskers plots of acetylcholine,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etylcarnitin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nicotinamide. </a:t>
            </a:r>
          </a:p>
          <a:p>
            <a:r>
              <a:rPr lang="en-US" dirty="0"/>
              <a:t>A –</a:t>
            </a:r>
            <a:r>
              <a:rPr lang="en-US" baseline="0" dirty="0"/>
              <a:t> Acetylcholine</a:t>
            </a:r>
          </a:p>
          <a:p>
            <a:r>
              <a:rPr lang="en-US" baseline="0" dirty="0"/>
              <a:t>B – </a:t>
            </a:r>
            <a:r>
              <a:rPr lang="en-US" baseline="0" dirty="0" err="1"/>
              <a:t>Acetylcarnitine</a:t>
            </a:r>
            <a:endParaRPr lang="en-US" baseline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/>
              <a:t>C – Nicotinamid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47B433-8E11-4A82-B2A3-F1E47187A98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6739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162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267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300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168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950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234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791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869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771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616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353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E6852C-917F-4939-A5A6-FD1DE0ED6536}" type="datetimeFigureOut">
              <a:rPr lang="en-US" smtClean="0"/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AD134-59F3-4A81-A6E4-7C8C15ED2B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588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sz="3600" dirty="0"/>
              <a:t>Supplemental Figures for PROTEOMIC, METABOLOMIC, and LIPIDOMIC ANALYSES OF LUNG TISSUE EXPOSED TO MUSTARD GAS</a:t>
            </a:r>
            <a:br>
              <a:rPr lang="en-US" sz="3600" dirty="0"/>
            </a:br>
            <a:endParaRPr lang="en-US" sz="36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91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3043084" y="878639"/>
          <a:ext cx="6105831" cy="5109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8" r:id="rId4" imgW="3658979" imgH="3061669" progId="Prism8.Document">
                  <p:embed/>
                </p:oleObj>
              </mc:Choice>
              <mc:Fallback>
                <p:oleObj name="Prism 8" r:id="rId4" imgW="3658979" imgH="306166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43084" y="878639"/>
                        <a:ext cx="6105831" cy="5109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146602" y="296808"/>
            <a:ext cx="45175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838499" y="3395592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276899" y="2562039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790204" y="2494576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293791" y="2561183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816498" y="2689626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321336" y="2731685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" name="TextBox 38"/>
          <p:cNvSpPr txBox="1"/>
          <p:nvPr/>
        </p:nvSpPr>
        <p:spPr>
          <a:xfrm>
            <a:off x="8283311" y="410832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38"/>
          <p:cNvSpPr txBox="1"/>
          <p:nvPr/>
        </p:nvSpPr>
        <p:spPr>
          <a:xfrm>
            <a:off x="7798671" y="410832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TextBox 38"/>
          <p:cNvSpPr txBox="1"/>
          <p:nvPr/>
        </p:nvSpPr>
        <p:spPr>
          <a:xfrm>
            <a:off x="7308670" y="409942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" name="TextBox 38"/>
          <p:cNvSpPr txBox="1"/>
          <p:nvPr/>
        </p:nvSpPr>
        <p:spPr>
          <a:xfrm>
            <a:off x="6824965" y="41078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" name="TextBox 38"/>
          <p:cNvSpPr txBox="1"/>
          <p:nvPr/>
        </p:nvSpPr>
        <p:spPr>
          <a:xfrm>
            <a:off x="6331858" y="41078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TextBox 38"/>
          <p:cNvSpPr txBox="1"/>
          <p:nvPr/>
        </p:nvSpPr>
        <p:spPr>
          <a:xfrm>
            <a:off x="5850172" y="41078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" name="TextBox 38"/>
          <p:cNvSpPr txBox="1"/>
          <p:nvPr/>
        </p:nvSpPr>
        <p:spPr>
          <a:xfrm>
            <a:off x="5349533" y="411485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" name="TextBox 38"/>
          <p:cNvSpPr txBox="1"/>
          <p:nvPr/>
        </p:nvSpPr>
        <p:spPr>
          <a:xfrm>
            <a:off x="4371961" y="38962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8" name="TextBox 38"/>
          <p:cNvSpPr txBox="1"/>
          <p:nvPr/>
        </p:nvSpPr>
        <p:spPr>
          <a:xfrm>
            <a:off x="4866182" y="396402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2416019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778" y="1704916"/>
            <a:ext cx="4092882" cy="30696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0340" y="1704915"/>
            <a:ext cx="4098068" cy="30696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9" name="Straight Connector 8"/>
          <p:cNvCxnSpPr/>
          <p:nvPr/>
        </p:nvCxnSpPr>
        <p:spPr>
          <a:xfrm>
            <a:off x="9567742" y="4707667"/>
            <a:ext cx="65420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9595619" y="4461447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21345" y="169498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edi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170341" y="1691271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D (0.1 mg/mL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58898" y="270933"/>
            <a:ext cx="42771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928778" y="5049711"/>
            <a:ext cx="833963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b="1" i="1" u="sng" dirty="0"/>
              <a:t>Supplemental Figure S2:</a:t>
            </a:r>
            <a:r>
              <a:rPr lang="en-US" b="1" i="1" dirty="0"/>
              <a:t> Epithelial detachment associated with HD exposure in </a:t>
            </a:r>
            <a:r>
              <a:rPr lang="en-US" b="1" i="1" dirty="0" err="1"/>
              <a:t>EpiAirway</a:t>
            </a:r>
            <a:r>
              <a:rPr lang="en-US" b="1" i="1" baseline="30000" dirty="0" err="1"/>
              <a:t>TM</a:t>
            </a:r>
            <a:r>
              <a:rPr lang="en-US" b="1" i="1" dirty="0"/>
              <a:t> tissues.</a:t>
            </a:r>
            <a:r>
              <a:rPr lang="en-US" dirty="0"/>
              <a:t> Paraffin-embedded sections from </a:t>
            </a:r>
            <a:r>
              <a:rPr lang="en-US" dirty="0" err="1"/>
              <a:t>EpiAirway</a:t>
            </a:r>
            <a:r>
              <a:rPr lang="en-US" baseline="30000" dirty="0" err="1"/>
              <a:t>TM</a:t>
            </a:r>
            <a:r>
              <a:rPr lang="en-US" dirty="0"/>
              <a:t> tissues exposed to media or HD (0.1 mg/mL; 0.629 </a:t>
            </a:r>
            <a:r>
              <a:rPr lang="en-US" dirty="0" err="1"/>
              <a:t>mM</a:t>
            </a:r>
            <a:r>
              <a:rPr lang="en-US" dirty="0"/>
              <a:t>) were rehydrated and stained with hematoxylin and eosin.</a:t>
            </a:r>
          </a:p>
        </p:txBody>
      </p:sp>
    </p:spTree>
    <p:extLst>
      <p:ext uri="{BB962C8B-B14F-4D97-AF65-F5344CB8AC3E}">
        <p14:creationId xmlns:p14="http://schemas.microsoft.com/office/powerpoint/2010/main" val="11430288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1" name="Group 170"/>
          <p:cNvGrpSpPr/>
          <p:nvPr/>
        </p:nvGrpSpPr>
        <p:grpSpPr>
          <a:xfrm>
            <a:off x="2794828" y="532678"/>
            <a:ext cx="6617843" cy="6199552"/>
            <a:chOff x="2782539" y="524929"/>
            <a:chExt cx="6617843" cy="6199552"/>
          </a:xfrm>
        </p:grpSpPr>
        <p:graphicFrame>
          <p:nvGraphicFramePr>
            <p:cNvPr id="172" name="Object 171"/>
            <p:cNvGraphicFramePr>
              <a:graphicFrameLocks noChangeAspect="1"/>
            </p:cNvGraphicFramePr>
            <p:nvPr>
              <p:extLst/>
            </p:nvPr>
          </p:nvGraphicFramePr>
          <p:xfrm>
            <a:off x="3461978" y="738293"/>
            <a:ext cx="2487416" cy="24857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2" name="Prism 8" r:id="rId4" imgW="2631512" imgH="2611837" progId="Prism8.Document">
                    <p:embed/>
                  </p:oleObj>
                </mc:Choice>
                <mc:Fallback>
                  <p:oleObj name="Prism 8" r:id="rId4" imgW="2631512" imgH="2611837" progId="Prism8.Document">
                    <p:embed/>
                    <p:pic>
                      <p:nvPicPr>
                        <p:cNvPr id="172" name="Object 171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461978" y="738293"/>
                          <a:ext cx="2487416" cy="24857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3" name="TextBox 172"/>
            <p:cNvSpPr txBox="1"/>
            <p:nvPr/>
          </p:nvSpPr>
          <p:spPr>
            <a:xfrm>
              <a:off x="3710225" y="3133679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dia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4409843" y="3137514"/>
              <a:ext cx="458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5055456" y="3129543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3138039" y="247234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3133737" y="207597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146445" y="167491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146445" y="125502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057489" y="825401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 rot="16200000">
              <a:off x="2334597" y="1835476"/>
              <a:ext cx="12811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l-GR" sz="14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5103865" y="1046735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4015896" y="650336"/>
              <a:ext cx="7377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4082964" y="3893554"/>
              <a:ext cx="595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IL-6</a:t>
              </a:r>
            </a:p>
          </p:txBody>
        </p:sp>
        <p:sp>
          <p:nvSpPr>
            <p:cNvPr id="185" name="Rectangle 184"/>
            <p:cNvSpPr/>
            <p:nvPr/>
          </p:nvSpPr>
          <p:spPr>
            <a:xfrm>
              <a:off x="2782539" y="545102"/>
              <a:ext cx="3162783" cy="297257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86" name="Group 185"/>
            <p:cNvGrpSpPr/>
            <p:nvPr/>
          </p:nvGrpSpPr>
          <p:grpSpPr>
            <a:xfrm>
              <a:off x="6255579" y="649705"/>
              <a:ext cx="3083451" cy="2758134"/>
              <a:chOff x="6004959" y="753410"/>
              <a:chExt cx="3262773" cy="2897568"/>
            </a:xfrm>
          </p:grpSpPr>
          <p:graphicFrame>
            <p:nvGraphicFramePr>
              <p:cNvPr id="216" name="Object 215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6635657" y="829221"/>
              <a:ext cx="2632075" cy="26114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103" name="Prism 8" r:id="rId6" imgW="2631512" imgH="2611837" progId="Prism8.Document">
                      <p:embed/>
                    </p:oleObj>
                  </mc:Choice>
                  <mc:Fallback>
                    <p:oleObj name="Prism 8" r:id="rId6" imgW="2631512" imgH="2611837" progId="Prism8.Document">
                      <p:embed/>
                      <p:pic>
                        <p:nvPicPr>
                          <p:cNvPr id="216" name="Object 215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6635657" y="829221"/>
                            <a:ext cx="2632075" cy="26114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17" name="TextBox 216"/>
              <p:cNvSpPr txBox="1"/>
              <p:nvPr/>
            </p:nvSpPr>
            <p:spPr>
              <a:xfrm>
                <a:off x="6918720" y="3346531"/>
                <a:ext cx="656780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dia</a:t>
                </a: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7650065" y="3350560"/>
                <a:ext cx="484986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8324265" y="3359976"/>
                <a:ext cx="429484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D</a:t>
                </a: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 rot="16200000">
                <a:off x="5494854" y="1981529"/>
                <a:ext cx="1345885" cy="3256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L-1</a:t>
                </a:r>
                <a:r>
                  <a:rPr lang="el-GR" sz="14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6375473" y="2381673"/>
                <a:ext cx="375205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6290514" y="1666984"/>
                <a:ext cx="465106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6294792" y="929817"/>
                <a:ext cx="465106" cy="2910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8370272" y="1005248"/>
                <a:ext cx="322623" cy="4850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7269294" y="753410"/>
                <a:ext cx="778908" cy="3880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L-1</a:t>
                </a:r>
                <a:r>
                  <a:rPr lang="el-GR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7" name="Rectangle 186"/>
            <p:cNvSpPr/>
            <p:nvPr/>
          </p:nvSpPr>
          <p:spPr>
            <a:xfrm>
              <a:off x="6232977" y="524929"/>
              <a:ext cx="3162783" cy="297257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188" name="Object 187"/>
            <p:cNvGraphicFramePr>
              <a:graphicFrameLocks noChangeAspect="1"/>
            </p:cNvGraphicFramePr>
            <p:nvPr>
              <p:extLst/>
            </p:nvPr>
          </p:nvGraphicFramePr>
          <p:xfrm>
            <a:off x="3458148" y="3978160"/>
            <a:ext cx="2487416" cy="24857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4" name="Prism 8" r:id="rId8" imgW="2631512" imgH="2611837" progId="Prism8.Document">
                    <p:embed/>
                  </p:oleObj>
                </mc:Choice>
                <mc:Fallback>
                  <p:oleObj name="Prism 8" r:id="rId8" imgW="2631512" imgH="2611837" progId="Prism8.Document">
                    <p:embed/>
                    <p:pic>
                      <p:nvPicPr>
                        <p:cNvPr id="188" name="Object 187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458148" y="3978160"/>
                          <a:ext cx="2487416" cy="24857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89" name="TextBox 188"/>
            <p:cNvSpPr txBox="1"/>
            <p:nvPr/>
          </p:nvSpPr>
          <p:spPr>
            <a:xfrm>
              <a:off x="3727640" y="6409594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dia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4418790" y="6413429"/>
              <a:ext cx="458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5055936" y="6409592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3125812" y="572266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3121509" y="532629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3134217" y="492522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3134217" y="450534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3045262" y="4075717"/>
              <a:ext cx="5245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 rot="16200000">
              <a:off x="2359239" y="5098592"/>
              <a:ext cx="12073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6 (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5095879" y="4015453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99" name="Rectangle 198"/>
            <p:cNvSpPr/>
            <p:nvPr/>
          </p:nvSpPr>
          <p:spPr>
            <a:xfrm>
              <a:off x="2786933" y="3751502"/>
              <a:ext cx="3162783" cy="297257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200" name="Object 199"/>
            <p:cNvGraphicFramePr>
              <a:graphicFrameLocks noChangeAspect="1"/>
            </p:cNvGraphicFramePr>
            <p:nvPr>
              <p:extLst/>
            </p:nvPr>
          </p:nvGraphicFramePr>
          <p:xfrm>
            <a:off x="6845098" y="3977180"/>
            <a:ext cx="2487416" cy="24857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05" name="Prism 8" r:id="rId10" imgW="2631512" imgH="2611837" progId="Prism8.Document">
                    <p:embed/>
                  </p:oleObj>
                </mc:Choice>
                <mc:Fallback>
                  <p:oleObj name="Prism 8" r:id="rId10" imgW="2631512" imgH="2611837" progId="Prism8.Document">
                    <p:embed/>
                    <p:pic>
                      <p:nvPicPr>
                        <p:cNvPr id="200" name="Object 199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845098" y="3977180"/>
                          <a:ext cx="2487416" cy="24857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1" name="TextBox 200"/>
            <p:cNvSpPr txBox="1"/>
            <p:nvPr/>
          </p:nvSpPr>
          <p:spPr>
            <a:xfrm>
              <a:off x="8437376" y="6409614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D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7796152" y="6409613"/>
              <a:ext cx="458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7120354" y="6409612"/>
              <a:ext cx="620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dia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7431684" y="3892627"/>
              <a:ext cx="7761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 rot="16200000">
              <a:off x="5726626" y="5104577"/>
              <a:ext cx="13484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8470942" y="4296367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6522284" y="4605760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6512145" y="408508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6524684" y="508903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6599511" y="561097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11" name="Rectangle 210"/>
            <p:cNvSpPr/>
            <p:nvPr/>
          </p:nvSpPr>
          <p:spPr>
            <a:xfrm>
              <a:off x="6237599" y="3751908"/>
              <a:ext cx="3162783" cy="297257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2785516" y="55008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6240376" y="533018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2785623" y="3757594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6249292" y="3759840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226" name="TextBox 225"/>
          <p:cNvSpPr txBox="1"/>
          <p:nvPr/>
        </p:nvSpPr>
        <p:spPr>
          <a:xfrm>
            <a:off x="4619545" y="5380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</p:spTree>
    <p:extLst>
      <p:ext uri="{BB962C8B-B14F-4D97-AF65-F5344CB8AC3E}">
        <p14:creationId xmlns:p14="http://schemas.microsoft.com/office/powerpoint/2010/main" val="25001578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S4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207" y="1878564"/>
            <a:ext cx="3505586" cy="38485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0649" y="2098372"/>
            <a:ext cx="4401351" cy="384852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169" y="1973237"/>
            <a:ext cx="3505586" cy="38485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860DC15-77AD-4B3A-BE3B-3E3109003F3B}"/>
              </a:ext>
            </a:extLst>
          </p:cNvPr>
          <p:cNvSpPr txBox="1"/>
          <p:nvPr/>
        </p:nvSpPr>
        <p:spPr>
          <a:xfrm>
            <a:off x="1892300" y="6141213"/>
            <a:ext cx="78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7E5FA7-660D-452B-8566-07AF3B63E102}"/>
              </a:ext>
            </a:extLst>
          </p:cNvPr>
          <p:cNvSpPr txBox="1"/>
          <p:nvPr/>
        </p:nvSpPr>
        <p:spPr>
          <a:xfrm>
            <a:off x="5956300" y="6110843"/>
            <a:ext cx="78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779DA2-0E14-4EA2-9C3E-74575FCFD454}"/>
              </a:ext>
            </a:extLst>
          </p:cNvPr>
          <p:cNvSpPr txBox="1"/>
          <p:nvPr/>
        </p:nvSpPr>
        <p:spPr>
          <a:xfrm>
            <a:off x="10020300" y="6036438"/>
            <a:ext cx="78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21631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6</TotalTime>
  <Words>413</Words>
  <Application>Microsoft Office PowerPoint</Application>
  <PresentationFormat>Widescreen</PresentationFormat>
  <Paragraphs>82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8</vt:lpstr>
      <vt:lpstr>Supplemental Figures for PROTEOMIC, METABOLOMIC, and LIPIDOMIC ANALYSES OF LUNG TISSUE EXPOSED TO MUSTARD GAS </vt:lpstr>
      <vt:lpstr>PowerPoint Presentation</vt:lpstr>
      <vt:lpstr>PowerPoint Presentation</vt:lpstr>
      <vt:lpstr>PowerPoint Presentation</vt:lpstr>
      <vt:lpstr>Supplemental Figure S4</vt:lpstr>
    </vt:vector>
  </TitlesOfParts>
  <Company>US Arm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PROTEOMIC, METABOLOMIC, and LIPIDOMIC ANALYSES OF LUNG TISSUE EXPOSED TO MUSTARD GAS</dc:title>
  <dc:creator>Dhummakupt, Elizabeth S CIV USARMY CCDC CBC (US)</dc:creator>
  <cp:lastModifiedBy>MDPI</cp:lastModifiedBy>
  <cp:revision>58</cp:revision>
  <dcterms:created xsi:type="dcterms:W3CDTF">2022-03-18T13:59:59Z</dcterms:created>
  <dcterms:modified xsi:type="dcterms:W3CDTF">2022-08-30T09:52:41Z</dcterms:modified>
</cp:coreProperties>
</file>